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53" autoAdjust="0"/>
  </p:normalViewPr>
  <p:slideViewPr>
    <p:cSldViewPr snapToGrid="0">
      <p:cViewPr varScale="1">
        <p:scale>
          <a:sx n="106" d="100"/>
          <a:sy n="106" d="100"/>
        </p:scale>
        <p:origin x="12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847854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90289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898379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83415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048729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500865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502574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29630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41802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004550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04752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2A5FF-40E9-438D-A9EC-3B4E169A8B75}" type="datetimeFigureOut">
              <a:rPr lang="fi-FI" smtClean="0"/>
              <a:t>24.3.2017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2DA51-CAC4-41C6-B0A9-AE93541613B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44251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2411680" y="785809"/>
            <a:ext cx="7169152" cy="4759306"/>
            <a:chOff x="4324350" y="-63771"/>
            <a:chExt cx="7169152" cy="4759306"/>
          </a:xfrm>
        </p:grpSpPr>
        <p:sp>
          <p:nvSpPr>
            <p:cNvPr id="5" name="TextBox 4"/>
            <p:cNvSpPr txBox="1"/>
            <p:nvPr/>
          </p:nvSpPr>
          <p:spPr>
            <a:xfrm>
              <a:off x="4356100" y="-63771"/>
              <a:ext cx="3467100" cy="64633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76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etal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d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ood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NA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s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ailable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e-wid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ylation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 using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finium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uman Methylation 450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eadChip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956550" y="3627872"/>
              <a:ext cx="3536952" cy="83099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lg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amples excluded: 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ssing chronological gestational ag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and </a:t>
              </a:r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utlier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epigenetic gestational age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gt;5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ndard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viations 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324350" y="3183224"/>
              <a:ext cx="3498850" cy="64633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17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etal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d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lood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NA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s</a:t>
              </a:r>
              <a:endParaRPr lang="fi-FI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id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ormation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n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e-wide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ylation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type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ata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324351" y="4233870"/>
              <a:ext cx="3511550" cy="46166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14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etal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d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lood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NA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s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fi-FI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th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ild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pigenetic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stational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e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324350" y="2125258"/>
              <a:ext cx="3486150" cy="64633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25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etal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d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lood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NA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s</a:t>
              </a:r>
              <a:endParaRPr lang="fi-FI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ssed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ality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cedures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</a:p>
            <a:p>
              <a:pPr algn="ctr"/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d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ull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formation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n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e-wide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ylation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950201" y="2468296"/>
              <a:ext cx="3543300" cy="1015663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lg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samples excluded: 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l rat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low 98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, IBD estimate &gt; 0.125 and could not be resolved and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crepancies between phenotypic and genotypic sex in 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e-wid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type data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 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7937500" y="182200"/>
              <a:ext cx="3543300" cy="1200329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lg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 samples excluded: 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uplicates, outliers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the median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nsitie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cross-hybridizing probes or probes containing SNPs and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pG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ith a detection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value &gt; 0.01 in at least 50% of the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s,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ue to location on chromosome X or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x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crepancies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349750" y="1037647"/>
              <a:ext cx="3486150" cy="64633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34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etal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d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ood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NA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s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ll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formation</a:t>
              </a:r>
              <a:r>
                <a:rPr lang="fi-FI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n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e-wide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ylation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NAm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stational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e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s</a:t>
              </a:r>
              <a:r>
                <a:rPr lang="fi-FI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i-FI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culated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943850" y="1674545"/>
              <a:ext cx="3543300" cy="46166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lg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 samples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ed: 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ternal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ood contamination</a:t>
              </a:r>
              <a:endParaRPr lang="fi-FI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Straight Arrow Connector 30"/>
            <p:cNvCxnSpPr/>
            <p:nvPr/>
          </p:nvCxnSpPr>
          <p:spPr>
            <a:xfrm>
              <a:off x="6092825" y="599576"/>
              <a:ext cx="248" cy="40577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/>
            <p:nvPr/>
          </p:nvCxnSpPr>
          <p:spPr>
            <a:xfrm>
              <a:off x="6079877" y="1699470"/>
              <a:ext cx="248" cy="40577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/>
            <p:cNvCxnSpPr/>
            <p:nvPr/>
          </p:nvCxnSpPr>
          <p:spPr>
            <a:xfrm>
              <a:off x="6060827" y="2763380"/>
              <a:ext cx="248" cy="40577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>
              <a:off x="6073527" y="3825653"/>
              <a:ext cx="248" cy="40577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 flipH="1" flipV="1">
              <a:off x="6194424" y="4018434"/>
              <a:ext cx="1755777" cy="253"/>
            </a:xfrm>
            <a:prstGeom prst="straightConnector1">
              <a:avLst/>
            </a:prstGeom>
            <a:ln w="19050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 flipH="1" flipV="1">
              <a:off x="6175373" y="2975599"/>
              <a:ext cx="1755777" cy="253"/>
            </a:xfrm>
            <a:prstGeom prst="straightConnector1">
              <a:avLst/>
            </a:prstGeom>
            <a:ln w="19050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 flipH="1" flipV="1">
              <a:off x="6159500" y="1897514"/>
              <a:ext cx="1755777" cy="253"/>
            </a:xfrm>
            <a:prstGeom prst="straightConnector1">
              <a:avLst/>
            </a:prstGeom>
            <a:ln w="19050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 flipH="1" flipV="1">
              <a:off x="6161087" y="780101"/>
              <a:ext cx="1755777" cy="253"/>
            </a:xfrm>
            <a:prstGeom prst="straightConnector1">
              <a:avLst/>
            </a:prstGeom>
            <a:ln w="19050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2411680" y="434831"/>
            <a:ext cx="16289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fi-FI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fi-FI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.</a:t>
            </a:r>
            <a:endParaRPr lang="fi-FI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5320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1</TotalTime>
  <Words>184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Helsink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arez Figueiredo, Anna</dc:creator>
  <cp:lastModifiedBy>Girchenko, Polina</cp:lastModifiedBy>
  <cp:revision>32</cp:revision>
  <dcterms:created xsi:type="dcterms:W3CDTF">2017-02-14T14:16:57Z</dcterms:created>
  <dcterms:modified xsi:type="dcterms:W3CDTF">2017-03-24T13:07:30Z</dcterms:modified>
</cp:coreProperties>
</file>